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3B908F-E985-4B45-B5BC-F644C67F8B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880C1F-3BD9-4334-A271-2C386F371A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B2D3E8-4F8B-4390-B9F5-2173DEF140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5F6657-E923-4693-9716-03B0683A6F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953AF1-C074-4126-8860-015F4D0579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EC60F2-D602-420E-8E81-282B6A6817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9C5893-5F59-4AAA-8DE4-E191C584C2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FAEC24-FEB1-44C7-864D-AAE497472D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EEC8AA-E892-49D9-9C6E-29F37D4A5E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DC0B91-2C1A-4B09-BE5A-C89D56EC45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765D79-6B8A-431E-96B9-9C13FBB250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DE2E04-3504-49ED-B9CC-04A0C98128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76C07A-DDB6-4156-A877-5DDAA84B055A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143000" y="2276640"/>
            <a:ext cx="6858000" cy="2387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Times New Roman"/>
              </a:rPr>
              <a:t>Internal validation of model coefficient and AUC in training set by bootstrapping </a:t>
            </a:r>
            <a:endParaRPr b="0" lang="en-US" sz="3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圖片 2" descr=""/>
          <p:cNvPicPr/>
          <p:nvPr/>
        </p:nvPicPr>
        <p:blipFill>
          <a:blip r:embed="rId1"/>
          <a:stretch/>
        </p:blipFill>
        <p:spPr>
          <a:xfrm>
            <a:off x="6480" y="262080"/>
            <a:ext cx="9131040" cy="6333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圖片 4" descr=""/>
          <p:cNvPicPr/>
          <p:nvPr/>
        </p:nvPicPr>
        <p:blipFill>
          <a:blip r:embed="rId1"/>
          <a:stretch/>
        </p:blipFill>
        <p:spPr>
          <a:xfrm>
            <a:off x="23760" y="179280"/>
            <a:ext cx="9120240" cy="6235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圖片 1" descr=""/>
          <p:cNvPicPr/>
          <p:nvPr/>
        </p:nvPicPr>
        <p:blipFill>
          <a:blip r:embed="rId1"/>
          <a:stretch/>
        </p:blipFill>
        <p:spPr>
          <a:xfrm>
            <a:off x="-12600" y="641520"/>
            <a:ext cx="9156600" cy="5786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圖片 1" descr=""/>
          <p:cNvPicPr/>
          <p:nvPr/>
        </p:nvPicPr>
        <p:blipFill>
          <a:blip r:embed="rId1"/>
          <a:stretch/>
        </p:blipFill>
        <p:spPr>
          <a:xfrm>
            <a:off x="0" y="515880"/>
            <a:ext cx="9147240" cy="5762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圖片 1" descr=""/>
          <p:cNvPicPr/>
          <p:nvPr/>
        </p:nvPicPr>
        <p:blipFill>
          <a:blip r:embed="rId1"/>
          <a:stretch/>
        </p:blipFill>
        <p:spPr>
          <a:xfrm>
            <a:off x="-6480" y="210960"/>
            <a:ext cx="9150480" cy="6282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22T04:00:53Z</dcterms:created>
  <dc:creator>user</dc:creator>
  <dc:description/>
  <dc:language>en-US</dc:language>
  <cp:lastModifiedBy>user</cp:lastModifiedBy>
  <dcterms:modified xsi:type="dcterms:W3CDTF">2016-08-27T17:01:04Z</dcterms:modified>
  <cp:revision>63</cp:revision>
  <dc:subject/>
  <dc:title>PowerPoint 簡報</dc:title>
</cp:coreProperties>
</file>